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3396" y="-5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metra.philippidou\Desktop\211%20NEW\211%20RESULTS%20INV-MIG\CM134-Migr-Inv-5%20cell%20lines-%20tracking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metra.philippidou\Desktop\211%20NEW\211%20RESULTS%20INV-MIG\CM134-Migr-Inv-5%20cell%20lines-%20trackin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metra.philippidou\Desktop\211%20NEW\211%20RESULTS%20INV-MIG\CM134-Migr-Inv-5%20cell%20lines-%20tracking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metra.philippidou\Desktop\211%20NEW\211%20RESULTS%20INV-MIG\CM134-Migr-Inv-5%20cell%20lines-%20track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NCM INV</c:v>
          </c:tx>
          <c:spPr>
            <a:solidFill>
              <a:schemeClr val="bg1">
                <a:lumMod val="9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71,'mimics 2^(DCt) + 2^(DDCt)'!$L$75)</c:f>
                <c:numCache>
                  <c:formatCode>General</c:formatCode>
                  <c:ptCount val="2"/>
                  <c:pt idx="0">
                    <c:v>0.55130228930018255</c:v>
                  </c:pt>
                  <c:pt idx="1">
                    <c:v>0.27879150165567496</c:v>
                  </c:pt>
                </c:numCache>
              </c:numRef>
            </c:plus>
            <c:minus>
              <c:numRef>
                <c:f>('mimics 2^(DCt) + 2^(DDCt)'!$L$71,'mimics 2^(DCt) + 2^(DDCt)'!$L$75)</c:f>
                <c:numCache>
                  <c:formatCode>General</c:formatCode>
                  <c:ptCount val="2"/>
                  <c:pt idx="0">
                    <c:v>0.55130228930018255</c:v>
                  </c:pt>
                  <c:pt idx="1">
                    <c:v>0.27879150165567496</c:v>
                  </c:pt>
                </c:numCache>
              </c:numRef>
            </c:minus>
          </c:errBars>
          <c:cat>
            <c:strRef>
              <c:f>'mimics 2^(DCt) + 2^(DDCt)'!$N$11:$N$12</c:f>
              <c:strCache>
                <c:ptCount val="2"/>
                <c:pt idx="0">
                  <c:v>48h</c:v>
                </c:pt>
                <c:pt idx="1">
                  <c:v>72h</c:v>
                </c:pt>
              </c:strCache>
            </c:strRef>
          </c:cat>
          <c:val>
            <c:numRef>
              <c:f>('mimics 2^(DCt) + 2^(DDCt)'!$K$71,'mimics 2^(DCt) + 2^(DDCt)'!$K$75)</c:f>
              <c:numCache>
                <c:formatCode>0.0</c:formatCode>
                <c:ptCount val="2"/>
                <c:pt idx="0">
                  <c:v>1.3036610374772284</c:v>
                </c:pt>
                <c:pt idx="1">
                  <c:v>0.70411510125292243</c:v>
                </c:pt>
              </c:numCache>
            </c:numRef>
          </c:val>
        </c:ser>
        <c:ser>
          <c:idx val="1"/>
          <c:order val="1"/>
          <c:tx>
            <c:v>NCM MIG</c:v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73,'mimics 2^(DCt) + 2^(DDCt)'!$L$77)</c:f>
                <c:numCache>
                  <c:formatCode>General</c:formatCode>
                  <c:ptCount val="2"/>
                  <c:pt idx="0">
                    <c:v>0.32407392937934343</c:v>
                  </c:pt>
                  <c:pt idx="1">
                    <c:v>1.5204844231057215E-2</c:v>
                  </c:pt>
                </c:numCache>
              </c:numRef>
            </c:plus>
            <c:minus>
              <c:numRef>
                <c:f>('mimics 2^(DCt) + 2^(DDCt)'!$L$73,'mimics 2^(DCt) + 2^(DDCt)'!$L$77)</c:f>
                <c:numCache>
                  <c:formatCode>General</c:formatCode>
                  <c:ptCount val="2"/>
                  <c:pt idx="0">
                    <c:v>0.32407392937934343</c:v>
                  </c:pt>
                  <c:pt idx="1">
                    <c:v>1.5204844231057215E-2</c:v>
                  </c:pt>
                </c:numCache>
              </c:numRef>
            </c:minus>
          </c:errBars>
          <c:val>
            <c:numRef>
              <c:f>('mimics 2^(DCt) + 2^(DDCt)'!$K$73,'mimics 2^(DCt) + 2^(DDCt)'!$K$77)</c:f>
              <c:numCache>
                <c:formatCode>0.0</c:formatCode>
                <c:ptCount val="2"/>
                <c:pt idx="0">
                  <c:v>0.39069897689959071</c:v>
                </c:pt>
                <c:pt idx="1">
                  <c:v>0.18269417573013341</c:v>
                </c:pt>
              </c:numCache>
            </c:numRef>
          </c:val>
        </c:ser>
        <c:ser>
          <c:idx val="2"/>
          <c:order val="2"/>
          <c:tx>
            <c:v>211M INV</c:v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79,'mimics 2^(DCt) + 2^(DDCt)'!$L$83)</c:f>
                <c:numCache>
                  <c:formatCode>General</c:formatCode>
                  <c:ptCount val="2"/>
                  <c:pt idx="0">
                    <c:v>66.636377334230247</c:v>
                  </c:pt>
                  <c:pt idx="1">
                    <c:v>45.269284288428992</c:v>
                  </c:pt>
                </c:numCache>
              </c:numRef>
            </c:plus>
            <c:minus>
              <c:numRef>
                <c:f>('mimics 2^(DCt) + 2^(DDCt)'!$L$79,'mimics 2^(DCt) + 2^(DDCt)'!$L$83)</c:f>
                <c:numCache>
                  <c:formatCode>General</c:formatCode>
                  <c:ptCount val="2"/>
                  <c:pt idx="0">
                    <c:v>66.636377334230247</c:v>
                  </c:pt>
                  <c:pt idx="1">
                    <c:v>45.269284288428992</c:v>
                  </c:pt>
                </c:numCache>
              </c:numRef>
            </c:minus>
          </c:errBars>
          <c:val>
            <c:numRef>
              <c:f>('mimics 2^(DCt) + 2^(DDCt)'!$K$79,'mimics 2^(DCt) + 2^(DDCt)'!$K$83)</c:f>
              <c:numCache>
                <c:formatCode>0.0</c:formatCode>
                <c:ptCount val="2"/>
                <c:pt idx="0">
                  <c:v>756.29508195953372</c:v>
                </c:pt>
                <c:pt idx="1">
                  <c:v>462.54918250971161</c:v>
                </c:pt>
              </c:numCache>
            </c:numRef>
          </c:val>
        </c:ser>
        <c:ser>
          <c:idx val="3"/>
          <c:order val="3"/>
          <c:tx>
            <c:v>211M MIG</c:v>
          </c:tx>
          <c:spPr>
            <a:solidFill>
              <a:schemeClr val="tx2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81,'mimics 2^(DCt) + 2^(DDCt)'!$L$85)</c:f>
                <c:numCache>
                  <c:formatCode>General</c:formatCode>
                  <c:ptCount val="2"/>
                  <c:pt idx="0">
                    <c:v>104.68532031748221</c:v>
                  </c:pt>
                  <c:pt idx="1">
                    <c:v>71.502180922454542</c:v>
                  </c:pt>
                </c:numCache>
              </c:numRef>
            </c:plus>
            <c:minus>
              <c:numRef>
                <c:f>('mimics 2^(DCt) + 2^(DDCt)'!$L$81,'mimics 2^(DCt) + 2^(DDCt)'!$L$85)</c:f>
                <c:numCache>
                  <c:formatCode>General</c:formatCode>
                  <c:ptCount val="2"/>
                  <c:pt idx="0">
                    <c:v>104.68532031748221</c:v>
                  </c:pt>
                  <c:pt idx="1">
                    <c:v>71.502180922454542</c:v>
                  </c:pt>
                </c:numCache>
              </c:numRef>
            </c:minus>
          </c:errBars>
          <c:val>
            <c:numRef>
              <c:f>('mimics 2^(DCt) + 2^(DDCt)'!$K$81,'mimics 2^(DCt) + 2^(DDCt)'!$K$85)</c:f>
              <c:numCache>
                <c:formatCode>0.0</c:formatCode>
                <c:ptCount val="2"/>
                <c:pt idx="0">
                  <c:v>650.0536440478478</c:v>
                </c:pt>
                <c:pt idx="1">
                  <c:v>443.999723409625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049408"/>
        <c:axId val="30051712"/>
      </c:barChart>
      <c:catAx>
        <c:axId val="30049408"/>
        <c:scaling>
          <c:orientation val="minMax"/>
        </c:scaling>
        <c:delete val="0"/>
        <c:axPos val="b"/>
        <c:majorTickMark val="out"/>
        <c:minorTickMark val="none"/>
        <c:tickLblPos val="nextTo"/>
        <c:crossAx val="30051712"/>
        <c:crosses val="autoZero"/>
        <c:auto val="1"/>
        <c:lblAlgn val="ctr"/>
        <c:lblOffset val="100"/>
        <c:noMultiLvlLbl val="0"/>
      </c:catAx>
      <c:valAx>
        <c:axId val="30051712"/>
        <c:scaling>
          <c:orientation val="minMax"/>
          <c:max val="10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30049408"/>
        <c:crosses val="autoZero"/>
        <c:crossBetween val="between"/>
        <c:majorUnit val="200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600" b="1"/>
            </a:pPr>
            <a:endParaRPr lang="en-US"/>
          </a:p>
        </c:txPr>
      </c:dTable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imics 2^(DCt) + 2^(DDCt)'!$N$19</c:f>
              <c:strCache>
                <c:ptCount val="1"/>
                <c:pt idx="0">
                  <c:v>NCM INV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3,'mimics 2^(DCt) + 2^(DDCt)'!$L$7)</c:f>
                <c:numCache>
                  <c:formatCode>General</c:formatCode>
                  <c:ptCount val="2"/>
                  <c:pt idx="0">
                    <c:v>3.4429021563291876E-2</c:v>
                  </c:pt>
                  <c:pt idx="1">
                    <c:v>0.11220546916221598</c:v>
                  </c:pt>
                </c:numCache>
              </c:numRef>
            </c:plus>
            <c:minus>
              <c:numRef>
                <c:f>('mimics 2^(DCt) + 2^(DDCt)'!$L$3,'mimics 2^(DCt) + 2^(DDCt)'!$L$7)</c:f>
                <c:numCache>
                  <c:formatCode>General</c:formatCode>
                  <c:ptCount val="2"/>
                  <c:pt idx="0">
                    <c:v>3.4429021563291876E-2</c:v>
                  </c:pt>
                  <c:pt idx="1">
                    <c:v>0.11220546916221598</c:v>
                  </c:pt>
                </c:numCache>
              </c:numRef>
            </c:minus>
          </c:errBars>
          <c:cat>
            <c:strRef>
              <c:f>'mimics 2^(DCt) + 2^(DDCt)'!$N$11:$N$12</c:f>
              <c:strCache>
                <c:ptCount val="2"/>
                <c:pt idx="0">
                  <c:v>48h</c:v>
                </c:pt>
                <c:pt idx="1">
                  <c:v>72h</c:v>
                </c:pt>
              </c:strCache>
            </c:strRef>
          </c:cat>
          <c:val>
            <c:numRef>
              <c:f>('mimics 2^(DCt) + 2^(DDCt)'!$K$3,'mimics 2^(DCt) + 2^(DDCt)'!$K$7)</c:f>
              <c:numCache>
                <c:formatCode>0.0</c:formatCode>
                <c:ptCount val="2"/>
                <c:pt idx="0">
                  <c:v>0.27090317074036147</c:v>
                </c:pt>
                <c:pt idx="1">
                  <c:v>0.17947498282952373</c:v>
                </c:pt>
              </c:numCache>
            </c:numRef>
          </c:val>
        </c:ser>
        <c:ser>
          <c:idx val="1"/>
          <c:order val="1"/>
          <c:tx>
            <c:strRef>
              <c:f>'mimics 2^(DCt) + 2^(DDCt)'!$N$20</c:f>
              <c:strCache>
                <c:ptCount val="1"/>
                <c:pt idx="0">
                  <c:v>NCM MI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5,'mimics 2^(DCt) + 2^(DDCt)'!$L$9)</c:f>
                <c:numCache>
                  <c:formatCode>General</c:formatCode>
                  <c:ptCount val="2"/>
                  <c:pt idx="0">
                    <c:v>6.7820459092947663E-2</c:v>
                  </c:pt>
                  <c:pt idx="1">
                    <c:v>4.655329836707834E-2</c:v>
                  </c:pt>
                </c:numCache>
              </c:numRef>
            </c:plus>
            <c:minus>
              <c:numRef>
                <c:f>('mimics 2^(DCt) + 2^(DDCt)'!$L$5,'mimics 2^(DCt) + 2^(DDCt)'!$L$9)</c:f>
                <c:numCache>
                  <c:formatCode>General</c:formatCode>
                  <c:ptCount val="2"/>
                  <c:pt idx="0">
                    <c:v>6.7820459092947663E-2</c:v>
                  </c:pt>
                  <c:pt idx="1">
                    <c:v>4.655329836707834E-2</c:v>
                  </c:pt>
                </c:numCache>
              </c:numRef>
            </c:minus>
          </c:errBars>
          <c:val>
            <c:numRef>
              <c:f>('mimics 2^(DCt) + 2^(DDCt)'!$K$5,'mimics 2^(DCt) + 2^(DDCt)'!$K$9)</c:f>
              <c:numCache>
                <c:formatCode>0.0</c:formatCode>
                <c:ptCount val="2"/>
                <c:pt idx="0">
                  <c:v>0.1227987255664913</c:v>
                </c:pt>
                <c:pt idx="1">
                  <c:v>7.7419721574370173E-2</c:v>
                </c:pt>
              </c:numCache>
            </c:numRef>
          </c:val>
        </c:ser>
        <c:ser>
          <c:idx val="2"/>
          <c:order val="2"/>
          <c:tx>
            <c:v>211M INV</c:v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11,'mimics 2^(DCt) + 2^(DDCt)'!$L$15)</c:f>
                <c:numCache>
                  <c:formatCode>General</c:formatCode>
                  <c:ptCount val="2"/>
                  <c:pt idx="0">
                    <c:v>7.5546553031247878</c:v>
                  </c:pt>
                  <c:pt idx="1">
                    <c:v>27.7180873077915</c:v>
                  </c:pt>
                </c:numCache>
              </c:numRef>
            </c:plus>
            <c:minus>
              <c:numRef>
                <c:f>('mimics 2^(DCt) + 2^(DDCt)'!$L$11,'mimics 2^(DCt) + 2^(DDCt)'!$L$15)</c:f>
                <c:numCache>
                  <c:formatCode>General</c:formatCode>
                  <c:ptCount val="2"/>
                  <c:pt idx="0">
                    <c:v>7.5546553031247878</c:v>
                  </c:pt>
                  <c:pt idx="1">
                    <c:v>27.7180873077915</c:v>
                  </c:pt>
                </c:numCache>
              </c:numRef>
            </c:minus>
          </c:errBars>
          <c:val>
            <c:numRef>
              <c:f>('mimics 2^(DCt) + 2^(DDCt)'!$K$11,'mimics 2^(DCt) + 2^(DDCt)'!$K$15)</c:f>
              <c:numCache>
                <c:formatCode>0.0</c:formatCode>
                <c:ptCount val="2"/>
                <c:pt idx="0">
                  <c:v>513.80530565812842</c:v>
                </c:pt>
                <c:pt idx="1">
                  <c:v>471.54358159767469</c:v>
                </c:pt>
              </c:numCache>
            </c:numRef>
          </c:val>
        </c:ser>
        <c:ser>
          <c:idx val="3"/>
          <c:order val="3"/>
          <c:tx>
            <c:v>211M MIG</c:v>
          </c:tx>
          <c:spPr>
            <a:solidFill>
              <a:schemeClr val="tx2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13,'mimics 2^(DCt) + 2^(DDCt)'!$L$17)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2.089645868615587</c:v>
                  </c:pt>
                </c:numCache>
              </c:numRef>
            </c:plus>
            <c:minus>
              <c:numRef>
                <c:f>('mimics 2^(DCt) + 2^(DDCt)'!$L$13,'mimics 2^(DCt) + 2^(DDCt)'!$L$17)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2.089645868615587</c:v>
                  </c:pt>
                </c:numCache>
              </c:numRef>
            </c:minus>
          </c:errBars>
          <c:val>
            <c:numRef>
              <c:f>('mimics 2^(DCt) + 2^(DDCt)'!$K$13,'mimics 2^(DCt) + 2^(DDCt)'!$K$17)</c:f>
              <c:numCache>
                <c:formatCode>0.0</c:formatCode>
                <c:ptCount val="2"/>
                <c:pt idx="0">
                  <c:v>393.44004640973105</c:v>
                </c:pt>
                <c:pt idx="1">
                  <c:v>322.174286770153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589120"/>
        <c:axId val="96437376"/>
      </c:barChart>
      <c:catAx>
        <c:axId val="95589120"/>
        <c:scaling>
          <c:orientation val="minMax"/>
        </c:scaling>
        <c:delete val="0"/>
        <c:axPos val="b"/>
        <c:majorTickMark val="out"/>
        <c:minorTickMark val="none"/>
        <c:tickLblPos val="nextTo"/>
        <c:crossAx val="96437376"/>
        <c:crosses val="autoZero"/>
        <c:auto val="1"/>
        <c:lblAlgn val="ctr"/>
        <c:lblOffset val="100"/>
        <c:noMultiLvlLbl val="0"/>
      </c:catAx>
      <c:valAx>
        <c:axId val="96437376"/>
        <c:scaling>
          <c:orientation val="minMax"/>
          <c:max val="10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95589120"/>
        <c:crosses val="autoZero"/>
        <c:crossBetween val="between"/>
        <c:majorUnit val="200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600" b="1"/>
            </a:pPr>
            <a:endParaRPr lang="en-US"/>
          </a:p>
        </c:txPr>
      </c:dTable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NCM INV</c:v>
          </c:tx>
          <c:spPr>
            <a:solidFill>
              <a:schemeClr val="bg1">
                <a:lumMod val="9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37,'mimics 2^(DCt) + 2^(DDCt)'!$L$41)</c:f>
                <c:numCache>
                  <c:formatCode>General</c:formatCode>
                  <c:ptCount val="2"/>
                  <c:pt idx="0">
                    <c:v>0.40404138028880182</c:v>
                  </c:pt>
                  <c:pt idx="1">
                    <c:v>1.4400007547775489</c:v>
                  </c:pt>
                </c:numCache>
              </c:numRef>
            </c:plus>
            <c:minus>
              <c:numRef>
                <c:f>('mimics 2^(DCt) + 2^(DDCt)'!$L$37,'mimics 2^(DCt) + 2^(DDCt)'!$L$41)</c:f>
                <c:numCache>
                  <c:formatCode>General</c:formatCode>
                  <c:ptCount val="2"/>
                  <c:pt idx="0">
                    <c:v>0.40404138028880182</c:v>
                  </c:pt>
                  <c:pt idx="1">
                    <c:v>1.4400007547775489</c:v>
                  </c:pt>
                </c:numCache>
              </c:numRef>
            </c:minus>
          </c:errBars>
          <c:cat>
            <c:strRef>
              <c:f>'mimics 2^(DCt) + 2^(DDCt)'!$N$11:$N$12</c:f>
              <c:strCache>
                <c:ptCount val="2"/>
                <c:pt idx="0">
                  <c:v>48h</c:v>
                </c:pt>
                <c:pt idx="1">
                  <c:v>72h</c:v>
                </c:pt>
              </c:strCache>
            </c:strRef>
          </c:cat>
          <c:val>
            <c:numRef>
              <c:f>('mimics 2^(DCt) + 2^(DDCt)'!$K$37,'mimics 2^(DCt) + 2^(DDCt)'!$K$41)</c:f>
              <c:numCache>
                <c:formatCode>0.0</c:formatCode>
                <c:ptCount val="2"/>
                <c:pt idx="0">
                  <c:v>0.99772549768071972</c:v>
                </c:pt>
                <c:pt idx="1">
                  <c:v>1.3767231106209084</c:v>
                </c:pt>
              </c:numCache>
            </c:numRef>
          </c:val>
        </c:ser>
        <c:ser>
          <c:idx val="1"/>
          <c:order val="1"/>
          <c:tx>
            <c:v>NCM MIG</c:v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39,'mimics 2^(DCt) + 2^(DDCt)'!$L$43)</c:f>
                <c:numCache>
                  <c:formatCode>General</c:formatCode>
                  <c:ptCount val="2"/>
                  <c:pt idx="0">
                    <c:v>0.21206079535882064</c:v>
                  </c:pt>
                  <c:pt idx="1">
                    <c:v>0.51482906990520882</c:v>
                  </c:pt>
                </c:numCache>
              </c:numRef>
            </c:plus>
            <c:minus>
              <c:numRef>
                <c:f>('mimics 2^(DCt) + 2^(DDCt)'!$L$39,'mimics 2^(DCt) + 2^(DDCt)'!$L$43)</c:f>
                <c:numCache>
                  <c:formatCode>General</c:formatCode>
                  <c:ptCount val="2"/>
                  <c:pt idx="0">
                    <c:v>0.21206079535882064</c:v>
                  </c:pt>
                  <c:pt idx="1">
                    <c:v>0.51482906990520882</c:v>
                  </c:pt>
                </c:numCache>
              </c:numRef>
            </c:minus>
          </c:errBars>
          <c:val>
            <c:numRef>
              <c:f>('mimics 2^(DCt) + 2^(DDCt)'!$K$39,'mimics 2^(DCt) + 2^(DDCt)'!$K$43)</c:f>
              <c:numCache>
                <c:formatCode>0.0</c:formatCode>
                <c:ptCount val="2"/>
                <c:pt idx="0">
                  <c:v>0.3006756048833798</c:v>
                </c:pt>
                <c:pt idx="1">
                  <c:v>0.55614852414293781</c:v>
                </c:pt>
              </c:numCache>
            </c:numRef>
          </c:val>
        </c:ser>
        <c:ser>
          <c:idx val="2"/>
          <c:order val="2"/>
          <c:tx>
            <c:v>211M INV</c:v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45,'mimics 2^(DCt) + 2^(DDCt)'!$L$49)</c:f>
                <c:numCache>
                  <c:formatCode>General</c:formatCode>
                  <c:ptCount val="2"/>
                  <c:pt idx="0">
                    <c:v>22.278223227824945</c:v>
                  </c:pt>
                  <c:pt idx="1">
                    <c:v>142.5239925295665</c:v>
                  </c:pt>
                </c:numCache>
              </c:numRef>
            </c:plus>
            <c:minus>
              <c:numRef>
                <c:f>('mimics 2^(DCt) + 2^(DDCt)'!$L$45,'mimics 2^(DCt) + 2^(DDCt)'!$L$49)</c:f>
                <c:numCache>
                  <c:formatCode>General</c:formatCode>
                  <c:ptCount val="2"/>
                  <c:pt idx="0">
                    <c:v>22.278223227824945</c:v>
                  </c:pt>
                  <c:pt idx="1">
                    <c:v>142.5239925295665</c:v>
                  </c:pt>
                </c:numCache>
              </c:numRef>
            </c:minus>
          </c:errBars>
          <c:val>
            <c:numRef>
              <c:f>('mimics 2^(DCt) + 2^(DDCt)'!$K$45,'mimics 2^(DCt) + 2^(DDCt)'!$K$49)</c:f>
              <c:numCache>
                <c:formatCode>0.0</c:formatCode>
                <c:ptCount val="2"/>
                <c:pt idx="0">
                  <c:v>568.31793980744862</c:v>
                </c:pt>
                <c:pt idx="1">
                  <c:v>508.09436128195557</c:v>
                </c:pt>
              </c:numCache>
            </c:numRef>
          </c:val>
        </c:ser>
        <c:ser>
          <c:idx val="3"/>
          <c:order val="3"/>
          <c:tx>
            <c:v>211m MIG</c:v>
          </c:tx>
          <c:spPr>
            <a:solidFill>
              <a:schemeClr val="tx2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47,'mimics 2^(DCt) + 2^(DDCt)'!$L$51)</c:f>
                <c:numCache>
                  <c:formatCode>General</c:formatCode>
                  <c:ptCount val="2"/>
                  <c:pt idx="0">
                    <c:v>37.031339913381714</c:v>
                  </c:pt>
                  <c:pt idx="1">
                    <c:v>32.252686023481104</c:v>
                  </c:pt>
                </c:numCache>
              </c:numRef>
            </c:plus>
            <c:minus>
              <c:numRef>
                <c:f>('mimics 2^(DCt) + 2^(DDCt)'!$L$47,'mimics 2^(DCt) + 2^(DDCt)'!$L$51)</c:f>
                <c:numCache>
                  <c:formatCode>General</c:formatCode>
                  <c:ptCount val="2"/>
                  <c:pt idx="0">
                    <c:v>37.031339913381714</c:v>
                  </c:pt>
                  <c:pt idx="1">
                    <c:v>32.252686023481104</c:v>
                  </c:pt>
                </c:numCache>
              </c:numRef>
            </c:minus>
          </c:errBars>
          <c:val>
            <c:numRef>
              <c:f>('mimics 2^(DCt) + 2^(DDCt)'!$K$47,'mimics 2^(DCt) + 2^(DDCt)'!$K$51)</c:f>
              <c:numCache>
                <c:formatCode>0.0</c:formatCode>
                <c:ptCount val="2"/>
                <c:pt idx="0">
                  <c:v>444.95096555075986</c:v>
                </c:pt>
                <c:pt idx="1">
                  <c:v>346.839781055075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285120"/>
        <c:axId val="103287424"/>
      </c:barChart>
      <c:catAx>
        <c:axId val="103285120"/>
        <c:scaling>
          <c:orientation val="minMax"/>
        </c:scaling>
        <c:delete val="0"/>
        <c:axPos val="b"/>
        <c:majorTickMark val="out"/>
        <c:minorTickMark val="none"/>
        <c:tickLblPos val="nextTo"/>
        <c:crossAx val="103287424"/>
        <c:crosses val="autoZero"/>
        <c:auto val="1"/>
        <c:lblAlgn val="ctr"/>
        <c:lblOffset val="100"/>
        <c:noMultiLvlLbl val="0"/>
      </c:catAx>
      <c:valAx>
        <c:axId val="103287424"/>
        <c:scaling>
          <c:orientation val="minMax"/>
          <c:max val="10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03285120"/>
        <c:crosses val="autoZero"/>
        <c:crossBetween val="between"/>
        <c:majorUnit val="200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600" b="1"/>
            </a:pPr>
            <a:endParaRPr lang="en-US"/>
          </a:p>
        </c:txPr>
      </c:dTable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imics 2^(DCt) + 2^(DDCt)'!$N$19</c:f>
              <c:strCache>
                <c:ptCount val="1"/>
                <c:pt idx="0">
                  <c:v>NCM INV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20,'mimics 2^(DCt) + 2^(DDCt)'!$L$24)</c:f>
                <c:numCache>
                  <c:formatCode>General</c:formatCode>
                  <c:ptCount val="2"/>
                  <c:pt idx="0">
                    <c:v>0.30617829282546372</c:v>
                  </c:pt>
                  <c:pt idx="1">
                    <c:v>0.20984062734118755</c:v>
                  </c:pt>
                </c:numCache>
              </c:numRef>
            </c:plus>
            <c:minus>
              <c:numRef>
                <c:f>('mimics 2^(DCt) + 2^(DDCt)'!$L$20,'mimics 2^(DCt) + 2^(DDCt)'!$L$24)</c:f>
                <c:numCache>
                  <c:formatCode>General</c:formatCode>
                  <c:ptCount val="2"/>
                  <c:pt idx="0">
                    <c:v>0.30617829282546372</c:v>
                  </c:pt>
                  <c:pt idx="1">
                    <c:v>0.20984062734118755</c:v>
                  </c:pt>
                </c:numCache>
              </c:numRef>
            </c:minus>
          </c:errBars>
          <c:cat>
            <c:strRef>
              <c:f>'mimics 2^(DCt) + 2^(DDCt)'!$N$11:$N$12</c:f>
              <c:strCache>
                <c:ptCount val="2"/>
                <c:pt idx="0">
                  <c:v>48h</c:v>
                </c:pt>
                <c:pt idx="1">
                  <c:v>72h</c:v>
                </c:pt>
              </c:strCache>
            </c:strRef>
          </c:cat>
          <c:val>
            <c:numRef>
              <c:f>('mimics 2^(DCt) + 2^(DDCt)'!$K$20,'mimics 2^(DCt) + 2^(DDCt)'!$K$24)</c:f>
              <c:numCache>
                <c:formatCode>0.0</c:formatCode>
                <c:ptCount val="2"/>
                <c:pt idx="0">
                  <c:v>10.412985765663089</c:v>
                </c:pt>
                <c:pt idx="1">
                  <c:v>14.271627671211867</c:v>
                </c:pt>
              </c:numCache>
            </c:numRef>
          </c:val>
        </c:ser>
        <c:ser>
          <c:idx val="1"/>
          <c:order val="1"/>
          <c:tx>
            <c:strRef>
              <c:f>'mimics 2^(DCt) + 2^(DDCt)'!$N$20</c:f>
              <c:strCache>
                <c:ptCount val="1"/>
                <c:pt idx="0">
                  <c:v>NCM MI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22,'mimics 2^(DCt) + 2^(DDCt)'!$L$26)</c:f>
                <c:numCache>
                  <c:formatCode>General</c:formatCode>
                  <c:ptCount val="2"/>
                  <c:pt idx="0">
                    <c:v>2.24199194822272</c:v>
                  </c:pt>
                  <c:pt idx="1">
                    <c:v>1.5383112205328415</c:v>
                  </c:pt>
                </c:numCache>
              </c:numRef>
            </c:plus>
            <c:minus>
              <c:numRef>
                <c:f>('mimics 2^(DCt) + 2^(DDCt)'!$L$22,'mimics 2^(DCt) + 2^(DDCt)'!$L$26)</c:f>
                <c:numCache>
                  <c:formatCode>General</c:formatCode>
                  <c:ptCount val="2"/>
                  <c:pt idx="0">
                    <c:v>2.24199194822272</c:v>
                  </c:pt>
                  <c:pt idx="1">
                    <c:v>1.5383112205328415</c:v>
                  </c:pt>
                </c:numCache>
              </c:numRef>
            </c:minus>
          </c:errBars>
          <c:val>
            <c:numRef>
              <c:f>('mimics 2^(DCt) + 2^(DDCt)'!$K$22,'mimics 2^(DCt) + 2^(DDCt)'!$K$26)</c:f>
              <c:numCache>
                <c:formatCode>0.0</c:formatCode>
                <c:ptCount val="2"/>
                <c:pt idx="0">
                  <c:v>11.231790331480028</c:v>
                </c:pt>
                <c:pt idx="1">
                  <c:v>16.542731558411639</c:v>
                </c:pt>
              </c:numCache>
            </c:numRef>
          </c:val>
        </c:ser>
        <c:ser>
          <c:idx val="2"/>
          <c:order val="2"/>
          <c:tx>
            <c:strRef>
              <c:f>'mimics 2^(DCt) + 2^(DDCt)'!$N$21</c:f>
              <c:strCache>
                <c:ptCount val="1"/>
                <c:pt idx="0">
                  <c:v>211M INV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28,'mimics 2^(DCt) + 2^(DDCt)'!$L$32)</c:f>
                <c:numCache>
                  <c:formatCode>General</c:formatCode>
                  <c:ptCount val="2"/>
                  <c:pt idx="0">
                    <c:v>18.435028405343154</c:v>
                  </c:pt>
                  <c:pt idx="1">
                    <c:v>164.7321533497562</c:v>
                  </c:pt>
                </c:numCache>
              </c:numRef>
            </c:plus>
            <c:minus>
              <c:numRef>
                <c:f>('mimics 2^(DCt) + 2^(DDCt)'!$L$28,'mimics 2^(DCt) + 2^(DDCt)'!$L$32)</c:f>
                <c:numCache>
                  <c:formatCode>General</c:formatCode>
                  <c:ptCount val="2"/>
                  <c:pt idx="0">
                    <c:v>18.435028405343154</c:v>
                  </c:pt>
                  <c:pt idx="1">
                    <c:v>164.7321533497562</c:v>
                  </c:pt>
                </c:numCache>
              </c:numRef>
            </c:minus>
          </c:errBars>
          <c:val>
            <c:numRef>
              <c:f>('mimics 2^(DCt) + 2^(DDCt)'!$K$28,'mimics 2^(DCt) + 2^(DDCt)'!$K$32)</c:f>
              <c:numCache>
                <c:formatCode>0.0</c:formatCode>
                <c:ptCount val="2"/>
                <c:pt idx="0">
                  <c:v>752.32728170430278</c:v>
                </c:pt>
                <c:pt idx="1">
                  <c:v>787.40464548855709</c:v>
                </c:pt>
              </c:numCache>
            </c:numRef>
          </c:val>
        </c:ser>
        <c:ser>
          <c:idx val="3"/>
          <c:order val="3"/>
          <c:tx>
            <c:strRef>
              <c:f>'mimics 2^(DCt) + 2^(DDCt)'!$N$22</c:f>
              <c:strCache>
                <c:ptCount val="1"/>
                <c:pt idx="0">
                  <c:v>211M MIG</c:v>
                </c:pt>
              </c:strCache>
            </c:strRef>
          </c:tx>
          <c:spPr>
            <a:solidFill>
              <a:schemeClr val="tx2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mimics 2^(DCt) + 2^(DDCt)'!$L$30,'mimics 2^(DCt) + 2^(DDCt)'!$L$34)</c:f>
                <c:numCache>
                  <c:formatCode>General</c:formatCode>
                  <c:ptCount val="2"/>
                  <c:pt idx="0">
                    <c:v>74.334925130711909</c:v>
                  </c:pt>
                  <c:pt idx="1">
                    <c:v>20.533019207884887</c:v>
                  </c:pt>
                </c:numCache>
              </c:numRef>
            </c:plus>
            <c:minus>
              <c:numRef>
                <c:f>('mimics 2^(DCt) + 2^(DDCt)'!$L$30,'mimics 2^(DCt) + 2^(DDCt)'!$L$34)</c:f>
                <c:numCache>
                  <c:formatCode>General</c:formatCode>
                  <c:ptCount val="2"/>
                  <c:pt idx="0">
                    <c:v>74.334925130711909</c:v>
                  </c:pt>
                  <c:pt idx="1">
                    <c:v>20.533019207884887</c:v>
                  </c:pt>
                </c:numCache>
              </c:numRef>
            </c:minus>
          </c:errBars>
          <c:val>
            <c:numRef>
              <c:f>('mimics 2^(DCt) + 2^(DDCt)'!$K$30,'mimics 2^(DCt) + 2^(DDCt)'!$K$34)</c:f>
              <c:numCache>
                <c:formatCode>0.0</c:formatCode>
                <c:ptCount val="2"/>
                <c:pt idx="0">
                  <c:v>723.48415241440296</c:v>
                </c:pt>
                <c:pt idx="1">
                  <c:v>598.5900596447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3501568"/>
        <c:axId val="123601664"/>
      </c:barChart>
      <c:catAx>
        <c:axId val="123501568"/>
        <c:scaling>
          <c:orientation val="minMax"/>
        </c:scaling>
        <c:delete val="0"/>
        <c:axPos val="b"/>
        <c:majorTickMark val="out"/>
        <c:minorTickMark val="none"/>
        <c:tickLblPos val="nextTo"/>
        <c:crossAx val="123601664"/>
        <c:crosses val="autoZero"/>
        <c:auto val="1"/>
        <c:lblAlgn val="ctr"/>
        <c:lblOffset val="100"/>
        <c:noMultiLvlLbl val="0"/>
      </c:catAx>
      <c:valAx>
        <c:axId val="123601664"/>
        <c:scaling>
          <c:orientation val="minMax"/>
          <c:max val="10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23501568"/>
        <c:crosses val="autoZero"/>
        <c:crossBetween val="between"/>
        <c:majorUnit val="200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600" b="1"/>
            </a:pPr>
            <a:endParaRPr lang="en-US"/>
          </a:p>
        </c:txPr>
      </c:dTable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86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734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07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599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802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027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783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602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26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229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908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2A01F-175A-48DE-A6CC-8616948F6A8E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83BC5-696F-4545-A697-B3904C00A4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33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304800" y="764104"/>
            <a:ext cx="5855917" cy="3503096"/>
            <a:chOff x="304800" y="764104"/>
            <a:chExt cx="5855917" cy="3503096"/>
          </a:xfrm>
        </p:grpSpPr>
        <p:grpSp>
          <p:nvGrpSpPr>
            <p:cNvPr id="18" name="Group 17"/>
            <p:cNvGrpSpPr/>
            <p:nvPr/>
          </p:nvGrpSpPr>
          <p:grpSpPr>
            <a:xfrm>
              <a:off x="304800" y="764104"/>
              <a:ext cx="2916260" cy="1660842"/>
              <a:chOff x="302003" y="2434746"/>
              <a:chExt cx="2916260" cy="1660842"/>
            </a:xfrm>
          </p:grpSpPr>
          <p:graphicFrame>
            <p:nvGraphicFramePr>
              <p:cNvPr id="6" name="Chart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75711078"/>
                  </p:ext>
                </p:extLst>
              </p:nvPr>
            </p:nvGraphicFramePr>
            <p:xfrm>
              <a:off x="302003" y="2622641"/>
              <a:ext cx="2916260" cy="147294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4" name="TextBox 13"/>
              <p:cNvSpPr txBox="1"/>
              <p:nvPr/>
            </p:nvSpPr>
            <p:spPr>
              <a:xfrm>
                <a:off x="1857678" y="2434746"/>
                <a:ext cx="4283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900" b="1" dirty="0" smtClean="0"/>
                  <a:t>A375</a:t>
                </a:r>
                <a:endParaRPr lang="en-US" sz="900" b="1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244457" y="764104"/>
              <a:ext cx="2916260" cy="1660842"/>
              <a:chOff x="3241660" y="2434746"/>
              <a:chExt cx="2916260" cy="1660842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93508538"/>
                  </p:ext>
                </p:extLst>
              </p:nvPr>
            </p:nvGraphicFramePr>
            <p:xfrm>
              <a:off x="3241660" y="2622641"/>
              <a:ext cx="2916260" cy="147294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5" name="TextBox 14"/>
              <p:cNvSpPr txBox="1"/>
              <p:nvPr/>
            </p:nvSpPr>
            <p:spPr>
              <a:xfrm>
                <a:off x="4724400" y="2434746"/>
                <a:ext cx="51007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900" b="1" dirty="0" err="1" smtClean="0"/>
                  <a:t>MeWo</a:t>
                </a:r>
                <a:endParaRPr lang="en-US" sz="900" b="1" dirty="0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304800" y="2797259"/>
              <a:ext cx="5855917" cy="1469941"/>
              <a:chOff x="0" y="0"/>
              <a:chExt cx="5855917" cy="1469941"/>
            </a:xfrm>
          </p:grpSpPr>
          <p:graphicFrame>
            <p:nvGraphicFramePr>
              <p:cNvPr id="8" name="Chart 7"/>
              <p:cNvGraphicFramePr>
                <a:graphicFrameLocks/>
              </p:cNvGraphicFramePr>
              <p:nvPr/>
            </p:nvGraphicFramePr>
            <p:xfrm>
              <a:off x="0" y="0"/>
              <a:ext cx="2916260" cy="146593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9" name="Chart 8"/>
              <p:cNvGraphicFramePr>
                <a:graphicFrameLocks/>
              </p:cNvGraphicFramePr>
              <p:nvPr/>
            </p:nvGraphicFramePr>
            <p:xfrm>
              <a:off x="2939657" y="0"/>
              <a:ext cx="2916260" cy="146994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11" name="TextBox 10"/>
            <p:cNvSpPr txBox="1"/>
            <p:nvPr/>
          </p:nvSpPr>
          <p:spPr>
            <a:xfrm rot="16200000">
              <a:off x="223779" y="3087016"/>
              <a:ext cx="87188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H" sz="700" b="1" dirty="0" smtClean="0"/>
                <a:t>miR-211 </a:t>
              </a:r>
              <a:r>
                <a:rPr lang="fr-CH" sz="700" b="1" dirty="0" err="1" smtClean="0"/>
                <a:t>levels</a:t>
              </a:r>
              <a:endParaRPr lang="en-US" sz="7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3171070" y="3085013"/>
              <a:ext cx="87188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H" sz="700" b="1" dirty="0" smtClean="0"/>
                <a:t>miR-211 </a:t>
              </a:r>
              <a:r>
                <a:rPr lang="fr-CH" sz="700" b="1" dirty="0" err="1" smtClean="0"/>
                <a:t>levels</a:t>
              </a:r>
              <a:endParaRPr lang="en-US" sz="7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06068" y="2596558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900" b="1" dirty="0" smtClean="0"/>
                <a:t>1102</a:t>
              </a:r>
              <a:endParaRPr lang="en-US" sz="9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727197" y="2596558"/>
              <a:ext cx="4700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900" b="1" dirty="0" smtClean="0"/>
                <a:t>IGR37</a:t>
              </a:r>
              <a:endParaRPr lang="en-US" sz="9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223777" y="1284330"/>
              <a:ext cx="87188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H" sz="700" b="1" dirty="0" smtClean="0"/>
                <a:t>miR-211 </a:t>
              </a:r>
              <a:r>
                <a:rPr lang="fr-CH" sz="700" b="1" dirty="0" err="1" smtClean="0"/>
                <a:t>levels</a:t>
              </a:r>
              <a:endParaRPr lang="en-US" sz="7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3171068" y="1282328"/>
              <a:ext cx="87188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H" sz="700" b="1" dirty="0" smtClean="0"/>
                <a:t>miR-211 </a:t>
              </a:r>
              <a:r>
                <a:rPr lang="fr-CH" sz="700" b="1" dirty="0" err="1" smtClean="0"/>
                <a:t>levels</a:t>
              </a:r>
              <a:endParaRPr lang="en-US" sz="7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86955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TLANT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e MARGUE</dc:creator>
  <cp:lastModifiedBy>Christiane MARGUE</cp:lastModifiedBy>
  <cp:revision>4</cp:revision>
  <cp:lastPrinted>2013-01-28T12:43:26Z</cp:lastPrinted>
  <dcterms:created xsi:type="dcterms:W3CDTF">2013-01-28T12:35:07Z</dcterms:created>
  <dcterms:modified xsi:type="dcterms:W3CDTF">2013-03-12T09:18:28Z</dcterms:modified>
</cp:coreProperties>
</file>